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92" autoAdjust="0"/>
    <p:restoredTop sz="82329" autoAdjust="0"/>
  </p:normalViewPr>
  <p:slideViewPr>
    <p:cSldViewPr snapToGrid="0" showGuides="1">
      <p:cViewPr>
        <p:scale>
          <a:sx n="200" d="100"/>
          <a:sy n="200" d="100"/>
        </p:scale>
        <p:origin x="-60" y="-21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182842-31B5-4C23-AABE-00713D53E4F0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0F1B22-2E3D-43B4-9D9D-829134CAE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833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ure 1E</a:t>
            </a:r>
          </a:p>
          <a:p>
            <a:r>
              <a:rPr kumimoji="1" lang="en-US" altLang="ja-JP" dirty="0" smtClean="0">
                <a:latin typeface="Symbol" panose="05050102010706020507" pitchFamily="18" charset="2"/>
              </a:rPr>
              <a:t>b</a:t>
            </a:r>
            <a:r>
              <a:rPr kumimoji="1" lang="en-US" altLang="ja-JP" dirty="0" smtClean="0"/>
              <a:t>-catenin GAPD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0F1B22-2E3D-43B4-9D9D-829134CAEF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4591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180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142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666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51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27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37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34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4388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359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1485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52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24573-3C93-4F58-AF59-F8AEA351BACC}" type="datetimeFigureOut">
              <a:rPr kumimoji="1" lang="ja-JP" altLang="en-US" smtClean="0"/>
              <a:t>2019/10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6168E-8A9A-4EA4-88DE-6F24DA15A5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3438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682" y="3033931"/>
            <a:ext cx="2767948" cy="2067696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563" y="660400"/>
            <a:ext cx="2750517" cy="2054570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5921829" y="3672114"/>
            <a:ext cx="1465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Symbol" panose="05050102010706020507" pitchFamily="18" charset="2"/>
              </a:rPr>
              <a:t>b</a:t>
            </a:r>
            <a:r>
              <a:rPr kumimoji="1" lang="en-US" altLang="ja-JP" sz="1400" b="1" dirty="0" smtClean="0"/>
              <a:t>-catenin 92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921828" y="4535715"/>
            <a:ext cx="1349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GAPDH 37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74914" y="5892800"/>
            <a:ext cx="5014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ure S5. Full length of western blot of Figure 1E.</a:t>
            </a:r>
            <a:endParaRPr kumimoji="1" lang="ja-JP" altLang="en-US" dirty="0"/>
          </a:p>
        </p:txBody>
      </p:sp>
      <p:sp>
        <p:nvSpPr>
          <p:cNvPr id="13" name="正方形/長方形 12"/>
          <p:cNvSpPr/>
          <p:nvPr/>
        </p:nvSpPr>
        <p:spPr>
          <a:xfrm>
            <a:off x="4622800" y="3730172"/>
            <a:ext cx="406400" cy="23948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4622800" y="4542972"/>
            <a:ext cx="384629" cy="24674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503151" y="3519715"/>
            <a:ext cx="736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NESC   ECSC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482" y="3019116"/>
            <a:ext cx="2807208" cy="2097024"/>
          </a:xfrm>
          <a:prstGeom prst="rect">
            <a:avLst/>
          </a:prstGeom>
        </p:spPr>
      </p:pic>
      <p:sp>
        <p:nvSpPr>
          <p:cNvPr id="17" name="テキスト ボックス 16"/>
          <p:cNvSpPr txBox="1"/>
          <p:nvPr/>
        </p:nvSpPr>
        <p:spPr>
          <a:xfrm>
            <a:off x="849086" y="5101771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5.42 sec</a:t>
            </a:r>
            <a:endParaRPr kumimoji="1" lang="ja-JP" altLang="en-US" sz="12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463143" y="5101771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9.8 sec</a:t>
            </a:r>
            <a:endParaRPr kumimoji="1" lang="ja-JP" altLang="en-US" sz="1200" dirty="0"/>
          </a:p>
        </p:txBody>
      </p:sp>
      <p:sp>
        <p:nvSpPr>
          <p:cNvPr id="19" name="正方形/長方形 18"/>
          <p:cNvSpPr/>
          <p:nvPr/>
        </p:nvSpPr>
        <p:spPr>
          <a:xfrm>
            <a:off x="1632857" y="3759201"/>
            <a:ext cx="406400" cy="23948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1632857" y="4572001"/>
            <a:ext cx="384629" cy="24674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13208" y="3548744"/>
            <a:ext cx="736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NESC   ECSC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60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12167"/>
            <a:ext cx="3820898" cy="2854118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7320" y="2135827"/>
            <a:ext cx="3820898" cy="285411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674914" y="5892800"/>
            <a:ext cx="5014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ure S6. Full length of western blot of Figure 4C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49086" y="5101771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</a:t>
            </a:r>
            <a:r>
              <a:rPr kumimoji="1" lang="en-US" altLang="ja-JP" sz="1200" dirty="0" smtClean="0"/>
              <a:t>126 </a:t>
            </a:r>
            <a:r>
              <a:rPr kumimoji="1" lang="en-US" altLang="ja-JP" sz="1200" dirty="0" smtClean="0"/>
              <a:t>sec</a:t>
            </a:r>
            <a:endParaRPr kumimoji="1" lang="ja-JP" altLang="en-US" sz="12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463143" y="5101771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</a:t>
            </a:r>
            <a:r>
              <a:rPr kumimoji="1" lang="en-US" altLang="ja-JP" sz="1200" dirty="0" smtClean="0"/>
              <a:t>1800 </a:t>
            </a:r>
            <a:r>
              <a:rPr kumimoji="1" lang="en-US" altLang="ja-JP" sz="1200" dirty="0" smtClean="0"/>
              <a:t>sec</a:t>
            </a:r>
            <a:endParaRPr kumimoji="1" lang="ja-JP" altLang="en-US" sz="12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550534" y="3948689"/>
            <a:ext cx="1349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GAPDH 37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6" name="正方形/長方形 15"/>
          <p:cNvSpPr/>
          <p:nvPr/>
        </p:nvSpPr>
        <p:spPr>
          <a:xfrm>
            <a:off x="6487889" y="3742706"/>
            <a:ext cx="255811" cy="136567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171810" y="3944359"/>
            <a:ext cx="1349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Symbol" panose="05050102010706020507" pitchFamily="18" charset="2"/>
              </a:rPr>
              <a:t>a</a:t>
            </a:r>
            <a:r>
              <a:rPr kumimoji="1" lang="en-US" altLang="ja-JP" sz="1400" b="1" dirty="0" smtClean="0"/>
              <a:t>-SMA  42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8" name="正方形/長方形 17"/>
          <p:cNvSpPr/>
          <p:nvPr/>
        </p:nvSpPr>
        <p:spPr>
          <a:xfrm>
            <a:off x="6748463" y="3745490"/>
            <a:ext cx="261937" cy="129309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382091" y="3508499"/>
            <a:ext cx="736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NESC   ECSC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1828800" y="3749965"/>
            <a:ext cx="277090" cy="14976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/>
          <p:cNvSpPr/>
          <p:nvPr/>
        </p:nvSpPr>
        <p:spPr>
          <a:xfrm>
            <a:off x="2105892" y="3743325"/>
            <a:ext cx="261072" cy="15310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763248" y="3557320"/>
            <a:ext cx="736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NESC   ECSC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67436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74914" y="5892800"/>
            <a:ext cx="5014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ure S7. Full length of western blot of Figure 4E</a:t>
            </a:r>
            <a:endParaRPr kumimoji="1" lang="ja-JP" altLang="en-US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598" y="462715"/>
            <a:ext cx="3236976" cy="2420112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4883" y="3039001"/>
            <a:ext cx="3236976" cy="2420112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712" y="3046258"/>
            <a:ext cx="3236976" cy="2420112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2213428" y="5486400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1.5 sec</a:t>
            </a:r>
            <a:endParaRPr kumimoji="1" lang="ja-JP" altLang="en-US" sz="12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827485" y="5486400"/>
            <a:ext cx="184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Exposure 7.2 sec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866742" y="4245427"/>
            <a:ext cx="1349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GAPDH 37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852229" y="4056742"/>
            <a:ext cx="1349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Symbol" panose="05050102010706020507" pitchFamily="18" charset="2"/>
              </a:rPr>
              <a:t>a</a:t>
            </a:r>
            <a:r>
              <a:rPr kumimoji="1" lang="en-US" altLang="ja-JP" sz="1400" b="1" dirty="0" smtClean="0"/>
              <a:t>-SMA  42 </a:t>
            </a:r>
            <a:r>
              <a:rPr kumimoji="1" lang="en-US" altLang="ja-JP" sz="1400" b="1" dirty="0" err="1" smtClean="0"/>
              <a:t>kDa</a:t>
            </a:r>
            <a:endParaRPr kumimoji="1" lang="ja-JP" altLang="en-US" sz="1400" b="1" dirty="0"/>
          </a:p>
        </p:txBody>
      </p:sp>
      <p:sp>
        <p:nvSpPr>
          <p:cNvPr id="12" name="正方形/長方形 11"/>
          <p:cNvSpPr/>
          <p:nvPr/>
        </p:nvSpPr>
        <p:spPr>
          <a:xfrm>
            <a:off x="7170057" y="4187372"/>
            <a:ext cx="638629" cy="1016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7170057" y="4339772"/>
            <a:ext cx="638629" cy="1016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894286" y="3947886"/>
            <a:ext cx="1233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Control  ICG-001  C-82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3381828" y="4100286"/>
            <a:ext cx="638629" cy="1016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3381828" y="4252686"/>
            <a:ext cx="638629" cy="1016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106057" y="3860800"/>
            <a:ext cx="1233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ea typeface="+mj-ea"/>
                <a:cs typeface="Helvetica" panose="020B0604020202020204" pitchFamily="34" charset="0"/>
              </a:rPr>
              <a:t>Control  ICG-001  C-82</a:t>
            </a:r>
            <a:endParaRPr kumimoji="1" lang="ja-JP" altLang="en-US" sz="800" b="1" dirty="0">
              <a:ea typeface="+mj-ea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734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</TotalTime>
  <Words>89</Words>
  <Application>Microsoft Office PowerPoint</Application>
  <PresentationFormat>画面に合わせる (4:3)</PresentationFormat>
  <Paragraphs>24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koh</dc:creator>
  <cp:lastModifiedBy>平川 東望子</cp:lastModifiedBy>
  <cp:revision>12</cp:revision>
  <dcterms:created xsi:type="dcterms:W3CDTF">2019-08-12T05:58:45Z</dcterms:created>
  <dcterms:modified xsi:type="dcterms:W3CDTF">2019-10-18T07:06:23Z</dcterms:modified>
</cp:coreProperties>
</file>